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E3D47-ADDC-4908-8238-F0F5502EEB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85B37-6120-49AD-B830-CDC6AF99F9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88926-6B47-45AD-828A-D41E3B14C9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692E5-1B84-4896-8C05-6141F98C64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1177A-3569-4B71-8848-2D51FA6D5B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1458E-9CD9-48D6-83ED-BFCC6F7328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D7022-A892-405D-B7D7-15398096FE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5E3C5-4B33-4FFC-8134-4765FF5668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F835F-D184-4600-AEF0-06A771C401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B5551-F79B-4470-AC7C-4FEAD19A71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FB7A35-65AC-4C60-A150-488CD92AE9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BC521-1BA1-4118-A56B-4D0CB06F0C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D8FE5A-6EE2-481B-9C59-A91F393DCF52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549360" y="4127400"/>
            <a:ext cx="150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27"/>
          <p:cNvGrpSpPr/>
          <p:nvPr/>
        </p:nvGrpSpPr>
        <p:grpSpPr>
          <a:xfrm>
            <a:off x="1268280" y="320760"/>
            <a:ext cx="4073760" cy="3208320"/>
            <a:chOff x="1268280" y="320760"/>
            <a:chExt cx="4073760" cy="3208320"/>
          </a:xfrm>
        </p:grpSpPr>
        <p:sp>
          <p:nvSpPr>
            <p:cNvPr id="43" name="圆角矩形 28"/>
            <p:cNvSpPr/>
            <p:nvPr/>
          </p:nvSpPr>
          <p:spPr>
            <a:xfrm>
              <a:off x="3718080" y="360360"/>
              <a:ext cx="1093680" cy="4888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Gram-negative bacteri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4" name="直接箭头连接符 29"/>
            <p:cNvCxnSpPr/>
            <p:nvPr/>
          </p:nvCxnSpPr>
          <p:spPr>
            <a:xfrm>
              <a:off x="4273200" y="853920"/>
              <a:ext cx="1080" cy="24984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sp>
          <p:nvSpPr>
            <p:cNvPr id="45" name="圆角矩形 30"/>
            <p:cNvSpPr/>
            <p:nvPr/>
          </p:nvSpPr>
          <p:spPr>
            <a:xfrm>
              <a:off x="3963960" y="1100160"/>
              <a:ext cx="596880" cy="4330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P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6" name="直接箭头连接符 31"/>
            <p:cNvCxnSpPr/>
            <p:nvPr/>
          </p:nvCxnSpPr>
          <p:spPr>
            <a:xfrm>
              <a:off x="4273200" y="1536840"/>
              <a:ext cx="1080" cy="25920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sp>
          <p:nvSpPr>
            <p:cNvPr id="47" name="圆角矩形 32"/>
            <p:cNvSpPr/>
            <p:nvPr/>
          </p:nvSpPr>
          <p:spPr>
            <a:xfrm>
              <a:off x="3805200" y="1792440"/>
              <a:ext cx="930240" cy="4330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ts val="16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TLR (TLR9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8" name="直接箭头连接符 33"/>
            <p:cNvCxnSpPr/>
            <p:nvPr/>
          </p:nvCxnSpPr>
          <p:spPr>
            <a:xfrm flipH="1">
              <a:off x="4265280" y="2221200"/>
              <a:ext cx="2160" cy="22608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sp>
          <p:nvSpPr>
            <p:cNvPr id="49" name="圆角矩形 34"/>
            <p:cNvSpPr/>
            <p:nvPr/>
          </p:nvSpPr>
          <p:spPr>
            <a:xfrm>
              <a:off x="3845160" y="2451240"/>
              <a:ext cx="831960" cy="4330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NF-κ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0" name="直接箭头连接符 35"/>
            <p:cNvCxnSpPr/>
            <p:nvPr/>
          </p:nvCxnSpPr>
          <p:spPr>
            <a:xfrm>
              <a:off x="4265640" y="2881440"/>
              <a:ext cx="2160" cy="21024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sp>
          <p:nvSpPr>
            <p:cNvPr id="51" name="圆角矩形 36"/>
            <p:cNvSpPr/>
            <p:nvPr/>
          </p:nvSpPr>
          <p:spPr>
            <a:xfrm>
              <a:off x="3192480" y="3096000"/>
              <a:ext cx="2149560" cy="4330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ts val="16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proinflammatory cytokines                    (IL-6 and TNF-α)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圆角矩形 37"/>
            <p:cNvSpPr/>
            <p:nvPr/>
          </p:nvSpPr>
          <p:spPr>
            <a:xfrm>
              <a:off x="1268280" y="415800"/>
              <a:ext cx="699840" cy="43308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1260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BPIFA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3" name="直接箭头连接符 38"/>
            <p:cNvCxnSpPr/>
            <p:nvPr/>
          </p:nvCxnSpPr>
          <p:spPr>
            <a:xfrm>
              <a:off x="1968120" y="630000"/>
              <a:ext cx="1751760" cy="360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cxnSp>
          <p:nvCxnSpPr>
            <p:cNvPr id="54" name="直接箭头连接符 39"/>
            <p:cNvCxnSpPr/>
            <p:nvPr/>
          </p:nvCxnSpPr>
          <p:spPr>
            <a:xfrm>
              <a:off x="1967760" y="629640"/>
              <a:ext cx="2001240" cy="68652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cxnSp>
          <p:nvCxnSpPr>
            <p:cNvPr id="55" name="直接箭头连接符 40"/>
            <p:cNvCxnSpPr/>
            <p:nvPr/>
          </p:nvCxnSpPr>
          <p:spPr>
            <a:xfrm>
              <a:off x="1968120" y="630000"/>
              <a:ext cx="1224720" cy="2680560"/>
            </a:xfrm>
            <a:prstGeom prst="straightConnector1">
              <a:avLst/>
            </a:prstGeom>
            <a:ln w="12600">
              <a:solidFill>
                <a:srgbClr val="0070c0"/>
              </a:solidFill>
              <a:miter/>
              <a:tailEnd len="med" type="arrow" w="med"/>
            </a:ln>
          </p:spPr>
        </p:cxnSp>
        <p:sp>
          <p:nvSpPr>
            <p:cNvPr id="56" name="文本框 16"/>
            <p:cNvSpPr/>
            <p:nvPr/>
          </p:nvSpPr>
          <p:spPr>
            <a:xfrm>
              <a:off x="2333520" y="320760"/>
              <a:ext cx="1384200" cy="30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ntimicrobial activit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文本框 17"/>
            <p:cNvSpPr/>
            <p:nvPr/>
          </p:nvSpPr>
          <p:spPr>
            <a:xfrm rot="3880800">
              <a:off x="1756800" y="1731600"/>
              <a:ext cx="1344600" cy="33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ntiinflammator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文本框 31"/>
            <p:cNvSpPr/>
            <p:nvPr/>
          </p:nvSpPr>
          <p:spPr>
            <a:xfrm rot="1147200">
              <a:off x="1887480" y="979560"/>
              <a:ext cx="2372040" cy="36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ntiinflammatory/Antimicrobial activ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Box 2"/>
          <p:cNvSpPr/>
          <p:nvPr/>
        </p:nvSpPr>
        <p:spPr>
          <a:xfrm>
            <a:off x="549360" y="4376880"/>
            <a:ext cx="568800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 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schematic diagram showing the antimicrobial and anti-inflammatory effects of BPI fold containing family A, member 1 (BPIFA1)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PIFA1 has antibacterial properties since it can bind bacterial lipopolysaccaride (LPS) and is likely to be bacteriostatic. Moreover, BPIFA1 could modulate the inflammatory response through the regulation of the Toll-like receptor (TLR) 9/NF-κB signaling pathway, which might further stimulate the expression of interleukin-6 (IL-6) and tumor necrosis factor-α (TNF-α). BPIFA1 can also directly regulate the proinflammatory cytokines such as IL-6 and TNF-α stimulated by the binding of LP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20T09:14:18Z</dcterms:created>
  <dc:creator>郭琳娜</dc:creator>
  <dc:description/>
  <dc:language>en-US</dc:language>
  <cp:lastModifiedBy>ggyue</cp:lastModifiedBy>
  <dcterms:modified xsi:type="dcterms:W3CDTF">2017-08-20T12:14:29Z</dcterms:modified>
  <cp:revision>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